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9906000" cy="6858000" type="A4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833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1400" y="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AD81F0-874A-4B35-B8CC-456C1C7859A8}" type="datetimeFigureOut">
              <a:rPr lang="zh-CN" altLang="en-US" smtClean="0"/>
              <a:t>2021/8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9717D2-9A83-4C5B-9B91-11439D88A99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079860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AD81F0-874A-4B35-B8CC-456C1C7859A8}" type="datetimeFigureOut">
              <a:rPr lang="zh-CN" altLang="en-US" smtClean="0"/>
              <a:t>2021/8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9717D2-9A83-4C5B-9B91-11439D88A99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583508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AD81F0-874A-4B35-B8CC-456C1C7859A8}" type="datetimeFigureOut">
              <a:rPr lang="zh-CN" altLang="en-US" smtClean="0"/>
              <a:t>2021/8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9717D2-9A83-4C5B-9B91-11439D88A99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042731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AD81F0-874A-4B35-B8CC-456C1C7859A8}" type="datetimeFigureOut">
              <a:rPr lang="zh-CN" altLang="en-US" smtClean="0"/>
              <a:t>2021/8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9717D2-9A83-4C5B-9B91-11439D88A99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643542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AD81F0-874A-4B35-B8CC-456C1C7859A8}" type="datetimeFigureOut">
              <a:rPr lang="zh-CN" altLang="en-US" smtClean="0"/>
              <a:t>2021/8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9717D2-9A83-4C5B-9B91-11439D88A99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796203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AD81F0-874A-4B35-B8CC-456C1C7859A8}" type="datetimeFigureOut">
              <a:rPr lang="zh-CN" altLang="en-US" smtClean="0"/>
              <a:t>2021/8/2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9717D2-9A83-4C5B-9B91-11439D88A99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704026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AD81F0-874A-4B35-B8CC-456C1C7859A8}" type="datetimeFigureOut">
              <a:rPr lang="zh-CN" altLang="en-US" smtClean="0"/>
              <a:t>2021/8/22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9717D2-9A83-4C5B-9B91-11439D88A99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059993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AD81F0-874A-4B35-B8CC-456C1C7859A8}" type="datetimeFigureOut">
              <a:rPr lang="zh-CN" altLang="en-US" smtClean="0"/>
              <a:t>2021/8/22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9717D2-9A83-4C5B-9B91-11439D88A99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169016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AD81F0-874A-4B35-B8CC-456C1C7859A8}" type="datetimeFigureOut">
              <a:rPr lang="zh-CN" altLang="en-US" smtClean="0"/>
              <a:t>2021/8/22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9717D2-9A83-4C5B-9B91-11439D88A99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897776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AD81F0-874A-4B35-B8CC-456C1C7859A8}" type="datetimeFigureOut">
              <a:rPr lang="zh-CN" altLang="en-US" smtClean="0"/>
              <a:t>2021/8/2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9717D2-9A83-4C5B-9B91-11439D88A99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776988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AD81F0-874A-4B35-B8CC-456C1C7859A8}" type="datetimeFigureOut">
              <a:rPr lang="zh-CN" altLang="en-US" smtClean="0"/>
              <a:t>2021/8/2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9717D2-9A83-4C5B-9B91-11439D88A99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362056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AD81F0-874A-4B35-B8CC-456C1C7859A8}" type="datetimeFigureOut">
              <a:rPr lang="zh-CN" altLang="en-US" smtClean="0"/>
              <a:t>2021/8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9717D2-9A83-4C5B-9B91-11439D88A99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115335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AEAD4CBA-EB38-4149-AF19-E354A3820841}"/>
              </a:ext>
            </a:extLst>
          </p:cNvPr>
          <p:cNvSpPr txBox="1"/>
          <p:nvPr/>
        </p:nvSpPr>
        <p:spPr>
          <a:xfrm>
            <a:off x="498682" y="323093"/>
            <a:ext cx="8908635" cy="88825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Supplementary Figure S4. </a:t>
            </a:r>
            <a:r>
              <a:rPr lang="en-US" altLang="zh-CN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The expression of 6 genes was associated with Ca</a:t>
            </a:r>
            <a:r>
              <a:rPr lang="en-US" altLang="zh-CN" sz="12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2+ </a:t>
            </a:r>
            <a:r>
              <a:rPr lang="en-US" altLang="zh-CN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concentration in pulp cells, as assessed via quantitative PCR. Control, healthy fruit; BP-H, healthy pulp of bitter pit fruit; BP, bitter pit fruit. Data are presented as mean ± standard error. **Highly significant data (</a:t>
            </a:r>
            <a:r>
              <a:rPr lang="en-US" altLang="zh-CN" sz="12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P</a:t>
            </a:r>
            <a:r>
              <a:rPr lang="en-US" altLang="zh-CN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 &lt; 0.01). </a:t>
            </a:r>
            <a:endParaRPr lang="zh-CN" altLang="zh-CN" sz="1200" dirty="0">
              <a:effectLst/>
              <a:latin typeface="宋体" panose="02010600030101010101" pitchFamily="2" charset="-122"/>
              <a:ea typeface="宋体" panose="02010600030101010101" pitchFamily="2" charset="-122"/>
              <a:cs typeface="宋体" panose="02010600030101010101" pitchFamily="2" charset="-122"/>
            </a:endParaRPr>
          </a:p>
        </p:txBody>
      </p:sp>
      <p:pic>
        <p:nvPicPr>
          <p:cNvPr id="7" name="图片 6" descr="图示&#10;&#10;描述已自动生成">
            <a:extLst>
              <a:ext uri="{FF2B5EF4-FFF2-40B4-BE49-F238E27FC236}">
                <a16:creationId xmlns:a16="http://schemas.microsoft.com/office/drawing/2014/main" id="{A67C031E-13FE-401E-BF9D-F119F180BFE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62555" y="1365608"/>
            <a:ext cx="5580888" cy="395630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886682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</TotalTime>
  <Words>63</Words>
  <Application>Microsoft Office PowerPoint</Application>
  <PresentationFormat>A4 纸张(210x297 毫米)</PresentationFormat>
  <Paragraphs>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宋体</vt:lpstr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qu haiyong</dc:creator>
  <cp:lastModifiedBy>qu haiyong</cp:lastModifiedBy>
  <cp:revision>2</cp:revision>
  <dcterms:created xsi:type="dcterms:W3CDTF">2021-08-17T13:08:56Z</dcterms:created>
  <dcterms:modified xsi:type="dcterms:W3CDTF">2021-08-21T17:53:23Z</dcterms:modified>
</cp:coreProperties>
</file>